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  <p:sldId id="259" r:id="rId3"/>
    <p:sldId id="257" r:id="rId4"/>
    <p:sldId id="258" r:id="rId5"/>
    <p:sldId id="256" r:id="rId6"/>
    <p:sldId id="265" r:id="rId7"/>
    <p:sldId id="260" r:id="rId8"/>
    <p:sldId id="261" r:id="rId9"/>
    <p:sldId id="264" r:id="rId10"/>
    <p:sldId id="262" r:id="rId11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00" autoAdjust="0"/>
    <p:restoredTop sz="94660"/>
  </p:normalViewPr>
  <p:slideViewPr>
    <p:cSldViewPr snapToGrid="0">
      <p:cViewPr varScale="1">
        <p:scale>
          <a:sx n="76" d="100"/>
          <a:sy n="76" d="100"/>
        </p:scale>
        <p:origin x="126" y="11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5CE4319-4C3D-427E-97BF-ECD7FDC0CB7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DA3F0E02-6AE4-4A43-B3D3-8224F27BFFB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9761C2B-CEBF-4020-BFC7-C256B7BCE0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4692D-9E7F-42D0-AA8B-750D854E7C2F}" type="datetimeFigureOut">
              <a:rPr kumimoji="1" lang="ja-JP" altLang="en-US" smtClean="0"/>
              <a:t>2023/12/4</a:t>
            </a:fld>
            <a:endParaRPr kumimoji="1" lang="ja-JP" altLang="en-US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70129FB-E5FB-4D96-B62B-FCE5D495C7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44638BD-8435-403E-9F8E-548A797102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1A7F9-CBE1-4C4A-AB2C-5DBB1BA9A2C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617655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EA8D21A-2F1E-4FEF-BF93-43A0852C33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E6A1685-F8C1-48A8-A761-31167FBEA83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CD23B87-A001-471F-A486-80E83308D8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4692D-9E7F-42D0-AA8B-750D854E7C2F}" type="datetimeFigureOut">
              <a:rPr kumimoji="1" lang="ja-JP" altLang="en-US" smtClean="0"/>
              <a:t>2023/12/4</a:t>
            </a:fld>
            <a:endParaRPr kumimoji="1" lang="ja-JP" altLang="en-US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CF4F807-2C61-4611-913F-DB9852D4A7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8A17FB6-848D-424B-A04B-6C6426C7B3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1A7F9-CBE1-4C4A-AB2C-5DBB1BA9A2C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0971632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6908B68-7849-4626-B5E9-CF27F3C0F7E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B662B17-FD18-4890-BBD3-1AC88E92EC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179CC3E-5153-488C-9734-F7CB17B431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4692D-9E7F-42D0-AA8B-750D854E7C2F}" type="datetimeFigureOut">
              <a:rPr kumimoji="1" lang="ja-JP" altLang="en-US" smtClean="0"/>
              <a:t>2023/12/4</a:t>
            </a:fld>
            <a:endParaRPr kumimoji="1" lang="ja-JP" altLang="en-US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286C539-C926-4D91-B5C8-D0955BFD71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4F390D0-B8E9-4D44-B42E-B306B03461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1A7F9-CBE1-4C4A-AB2C-5DBB1BA9A2C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8259497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F59A4C2-3BF1-4712-A7B5-E07C392BE4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F055922-7F6A-4253-A4A0-2B3C090026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9524940-AF80-44E2-9390-9DD4B084BC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4692D-9E7F-42D0-AA8B-750D854E7C2F}" type="datetimeFigureOut">
              <a:rPr kumimoji="1" lang="ja-JP" altLang="en-US" smtClean="0"/>
              <a:t>2023/12/4</a:t>
            </a:fld>
            <a:endParaRPr kumimoji="1" lang="ja-JP" altLang="en-US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B2F6CE7-D9B5-4192-8816-D14A604EAC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2AD10DA-6870-4272-A433-FEC3DA6C81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1A7F9-CBE1-4C4A-AB2C-5DBB1BA9A2C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263524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D3F68A-A0DD-4143-A05C-3C9AABD0DD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2934ECB-29B6-4097-892C-24D02DA959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CF6360E-878A-4C46-9096-C456A9D4A3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4692D-9E7F-42D0-AA8B-750D854E7C2F}" type="datetimeFigureOut">
              <a:rPr kumimoji="1" lang="ja-JP" altLang="en-US" smtClean="0"/>
              <a:t>2023/12/4</a:t>
            </a:fld>
            <a:endParaRPr kumimoji="1" lang="ja-JP" altLang="en-US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4D285E5-B1A5-4991-AA48-67DD4EC92C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E4D72CB-C928-49FF-B811-D571F0ABBF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1A7F9-CBE1-4C4A-AB2C-5DBB1BA9A2C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382188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B59AC46-253B-487F-BFF6-8B8A243C3E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273050C-97AA-4DE3-919C-FF88F7B7C76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69B8063-4B52-4B36-93A4-27A31CB462B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B8864D5-2946-4961-B0D3-8344402DC9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4692D-9E7F-42D0-AA8B-750D854E7C2F}" type="datetimeFigureOut">
              <a:rPr kumimoji="1" lang="ja-JP" altLang="en-US" smtClean="0"/>
              <a:t>2023/12/4</a:t>
            </a:fld>
            <a:endParaRPr kumimoji="1" lang="ja-JP" altLang="en-US" dirty="0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6B68441-B057-4E09-96CA-D5205E9BD7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EC051F0-F02C-411C-A52C-137243902C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1A7F9-CBE1-4C4A-AB2C-5DBB1BA9A2C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0014888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FC6EE78-264E-43BF-8B22-26D2283DB6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AEF19DA-4C43-4D88-8105-53FA7AA577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A7C6AE0-F332-43C7-ABDC-919918CCC96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0036C17-201C-42D3-AC7B-FBAA2F68BF9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0822D68-6A99-43A4-9DA9-5501DD95186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4368DA0-3708-4BB5-ABA9-E9E7A3B339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4692D-9E7F-42D0-AA8B-750D854E7C2F}" type="datetimeFigureOut">
              <a:rPr kumimoji="1" lang="ja-JP" altLang="en-US" smtClean="0"/>
              <a:t>2023/12/4</a:t>
            </a:fld>
            <a:endParaRPr kumimoji="1" lang="ja-JP" altLang="en-US" dirty="0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A7BE04A-44C2-4025-BED3-90FD208207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D1D6AC92-9E29-4695-BFF7-E639DF59B3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1A7F9-CBE1-4C4A-AB2C-5DBB1BA9A2C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515407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DFA9FA-6617-43FD-8348-BACABB6839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47D9E9E-292F-4D81-9562-F33C6D3992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4692D-9E7F-42D0-AA8B-750D854E7C2F}" type="datetimeFigureOut">
              <a:rPr kumimoji="1" lang="ja-JP" altLang="en-US" smtClean="0"/>
              <a:t>2023/12/4</a:t>
            </a:fld>
            <a:endParaRPr kumimoji="1" lang="ja-JP" altLang="en-US" dirty="0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F9102AF-8A6B-4C99-AA56-70DE095236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E232B60-4BB7-4FC8-88F5-DC33646AF6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1A7F9-CBE1-4C4A-AB2C-5DBB1BA9A2C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6960805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7E65E1AC-F341-4FFD-A1AB-46F84532B8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4692D-9E7F-42D0-AA8B-750D854E7C2F}" type="datetimeFigureOut">
              <a:rPr kumimoji="1" lang="ja-JP" altLang="en-US" smtClean="0"/>
              <a:t>2023/12/4</a:t>
            </a:fld>
            <a:endParaRPr kumimoji="1" lang="ja-JP" altLang="en-US" dirty="0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50C72326-D1C2-4D4E-A493-37E6488733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6E6BC4D-C2EE-470A-BB3D-1BC74E1B73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1A7F9-CBE1-4C4A-AB2C-5DBB1BA9A2C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7643678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4E97A6A-E654-41EE-B097-82093BE946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C9C5647-7BD4-4DF1-9630-F6C07EA25F2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B9C1CD1-9435-434A-983D-2C79BD83BE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AE47810-9156-44BD-8B1D-4DA6ED51E7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4692D-9E7F-42D0-AA8B-750D854E7C2F}" type="datetimeFigureOut">
              <a:rPr kumimoji="1" lang="ja-JP" altLang="en-US" smtClean="0"/>
              <a:t>2023/12/4</a:t>
            </a:fld>
            <a:endParaRPr kumimoji="1" lang="ja-JP" altLang="en-US" dirty="0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FF609CC-41AD-466C-BC21-19D5C9BDB5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7B80CF8-285B-47C9-8B20-BCA6359D8F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1A7F9-CBE1-4C4A-AB2C-5DBB1BA9A2C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7859171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69EFB3A-2972-4817-AA4B-37761CDB15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84D0CBA3-8195-4BD3-BC99-B6F9BA5D3D9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 dirty="0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875AE88-7FDE-4EDC-B6BE-4A2C423551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4968DEF-A533-4730-BAA5-68E6F117FB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4692D-9E7F-42D0-AA8B-750D854E7C2F}" type="datetimeFigureOut">
              <a:rPr kumimoji="1" lang="ja-JP" altLang="en-US" smtClean="0"/>
              <a:t>2023/12/4</a:t>
            </a:fld>
            <a:endParaRPr kumimoji="1" lang="ja-JP" altLang="en-US" dirty="0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3BD5FC7-21D2-4782-AB57-DE1F7F2B3E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C616093-36E2-4FF0-96EC-6F11129ECB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1A7F9-CBE1-4C4A-AB2C-5DBB1BA9A2C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129081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57B647B-E8CB-44B4-B42E-9FC8D6249E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723A1D3-0A63-4D2E-A2C8-B9EA212ED7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2D67BF2-CE97-4AD4-A5CC-E6FF8A45035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94692D-9E7F-42D0-AA8B-750D854E7C2F}" type="datetimeFigureOut">
              <a:rPr kumimoji="1" lang="ja-JP" altLang="en-US" smtClean="0"/>
              <a:t>2023/12/4</a:t>
            </a:fld>
            <a:endParaRPr kumimoji="1" lang="ja-JP" altLang="en-US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AC29BB5-795A-4F30-BDD6-C85B8F969F9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7E1DDDC-4F45-46B6-968F-8B32A6D563A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41A7F9-CBE1-4C4A-AB2C-5DBB1BA9A2C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1614416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7.png"/><Relationship Id="rId5" Type="http://schemas.openxmlformats.org/officeDocument/2006/relationships/image" Target="../media/image36.png"/><Relationship Id="rId4" Type="http://schemas.openxmlformats.org/officeDocument/2006/relationships/image" Target="../media/image35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6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7.png"/><Relationship Id="rId4" Type="http://schemas.openxmlformats.org/officeDocument/2006/relationships/image" Target="../media/image26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2.png"/><Relationship Id="rId5" Type="http://schemas.openxmlformats.org/officeDocument/2006/relationships/image" Target="../media/image31.png"/><Relationship Id="rId4" Type="http://schemas.openxmlformats.org/officeDocument/2006/relationships/image" Target="../media/image3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4DA363D5-4C34-41CC-9AC6-5684DFFA58C3}"/>
              </a:ext>
            </a:extLst>
          </p:cNvPr>
          <p:cNvSpPr/>
          <p:nvPr/>
        </p:nvSpPr>
        <p:spPr>
          <a:xfrm>
            <a:off x="0" y="28451"/>
            <a:ext cx="11911914" cy="67403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6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legends of supplementary figures.</a:t>
            </a:r>
            <a:endParaRPr lang="ja-JP" altLang="ja-JP" sz="16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6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6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6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. 1a. , 1b. </a:t>
            </a: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Full length blots of Figure 1c. </a:t>
            </a:r>
            <a:endParaRPr lang="ja-JP" altLang="ja-JP" sz="16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6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6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. 2. </a:t>
            </a: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ull length blots of Figure 2a.</a:t>
            </a:r>
            <a:endParaRPr lang="ja-JP" altLang="ja-JP" sz="16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6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6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. 3. </a:t>
            </a: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Western blots showing levels of cleaved caspase-3</a:t>
            </a:r>
            <a:r>
              <a:rPr lang="en-US" altLang="ja-JP" sz="16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(a) </a:t>
            </a: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nd </a:t>
            </a: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  <a:sym typeface="Symbol" panose="05050102010706020507" pitchFamily="18" charset="2"/>
              </a:rPr>
              <a:t></a:t>
            </a: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‑actin </a:t>
            </a:r>
            <a:r>
              <a:rPr lang="en-US" altLang="ja-JP" sz="16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b) </a:t>
            </a: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n mProx cells treated with FSP1 (FSP1+) or without FSP1 (FSP1-).</a:t>
            </a:r>
            <a:r>
              <a:rPr lang="en-US" altLang="ja-JP" sz="16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c,</a:t>
            </a: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Densitometric analysis of the blots. FSP1 significantly reduced levels of cleaved caspase-3 (P=0.00309). </a:t>
            </a:r>
            <a:endParaRPr lang="ja-JP" altLang="ja-JP" sz="16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6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6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. 4. </a:t>
            </a: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aseline effects of FSP1 overexpression in podocytes. </a:t>
            </a:r>
            <a:r>
              <a:rPr lang="en-US" altLang="ja-JP" sz="16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a)</a:t>
            </a: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here were no differences of renal function (serum BUN and creatinine) or levels of albuminuria between wild-type mice and FSP1 transgenic mice. </a:t>
            </a:r>
            <a:r>
              <a:rPr lang="en-US" altLang="ja-JP" sz="16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b, c) </a:t>
            </a: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o pathological changes were observed in RAGE knockout mice (</a:t>
            </a:r>
            <a:r>
              <a:rPr lang="en-US" altLang="ja-JP" sz="1600" i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ger-/-)</a:t>
            </a: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and FSP1 transgenic mice (FSP1.TG). FSP1-positive cells (resident fibroblasts) and areas within the kidney interstitium did not differ among wild-type, </a:t>
            </a:r>
            <a:r>
              <a:rPr lang="en-US" altLang="ja-JP" sz="1600" i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ger-/-</a:t>
            </a: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and FSP1.TG. Bars = 50 μm.</a:t>
            </a:r>
            <a:endParaRPr lang="ja-JP" altLang="ja-JP" sz="16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6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6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. 5. </a:t>
            </a: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aseline effects of FSP1 overexpression in podocytes on Nrf2-associated factors. Quantitative real-time PCR analysis of mRNA showed that heme oxygenase 1 (HO-1) and solute carrier family 7, member 11 (Slc7a11) were up-regulated in the renal cortex of FSP1 transgenic mice (FSP1.TG) compared to wild-type mice (Wild). By contrast, cystathionine gamma-lyase (CSE) and sequestosome 1 (sqstm 1) were not up-regulated in the same regions.</a:t>
            </a:r>
            <a:endParaRPr lang="ja-JP" altLang="ja-JP" sz="16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6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6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. 6. </a:t>
            </a: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leaved caspase-3-positive areas were significantly decreased in FSP1 transgenic mice (FSP1.TG </a:t>
            </a:r>
            <a:r>
              <a:rPr lang="en-US" altLang="ja-JP" sz="1600" i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ger+</a:t>
            </a: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/+) after cisplatin exposure but not in wild-type mice (Wild), RAGE knockout mice (</a:t>
            </a:r>
            <a:r>
              <a:rPr lang="en-US" altLang="ja-JP" sz="1600" i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ger-/-)</a:t>
            </a: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and FSP1.TG backcrossed with </a:t>
            </a:r>
            <a:r>
              <a:rPr lang="en-US" altLang="ja-JP" sz="1600" i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ger</a:t>
            </a:r>
            <a:r>
              <a:rPr lang="en-US" altLang="ja-JP" sz="1600" kern="100" baseline="300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-/-</a:t>
            </a: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(FSP1.TG </a:t>
            </a:r>
            <a:r>
              <a:rPr lang="en-US" altLang="ja-JP" sz="1600" i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ger</a:t>
            </a: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-/-) after cisplatin exposure. Bars = 20 μm.</a:t>
            </a:r>
            <a:endParaRPr lang="ja-JP" altLang="ja-JP" sz="16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6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6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. 7. </a:t>
            </a: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fter cisplatin exposure, podocytes and tubular epithelial cells in wild-type (Wild) and RAGE knockout mice (</a:t>
            </a:r>
            <a:r>
              <a:rPr lang="en-US" altLang="ja-JP" sz="1600" i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ger-</a:t>
            </a: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/-)  did not express FSP1. Interstitial fibroblasts expressed FSP1 in all mouse types tested, and FSP1-positive areas within the interstitium did not differ among them. Bars = 50 μm. FSP1.TG </a:t>
            </a:r>
            <a:r>
              <a:rPr lang="en-US" altLang="ja-JP" sz="1600" i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ger-/-, </a:t>
            </a: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SP1 transgenic mice backcrossed with RAGE knockout mice; FSP1.TG </a:t>
            </a:r>
            <a:r>
              <a:rPr lang="en-US" altLang="ja-JP" sz="1600" i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ger</a:t>
            </a: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+/+, FSP1 transgenic mice backcrossed with wild-type mice. </a:t>
            </a:r>
            <a:r>
              <a:rPr lang="ja-JP" altLang="en-US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</a:t>
            </a:r>
            <a:endParaRPr lang="ja-JP" altLang="ja-JP" sz="16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743528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図 11">
            <a:extLst>
              <a:ext uri="{FF2B5EF4-FFF2-40B4-BE49-F238E27FC236}">
                <a16:creationId xmlns:a16="http://schemas.microsoft.com/office/drawing/2014/main" id="{7DCF7F8B-2D14-42D2-8E39-882692C7C31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2100" y="1028828"/>
            <a:ext cx="3024124" cy="2284894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689C44A5-84B7-4417-9796-C51690889CF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69734" y="1016127"/>
            <a:ext cx="3046525" cy="2284894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8973807-B971-480F-B7B0-F528CED8C01F}"/>
              </a:ext>
            </a:extLst>
          </p:cNvPr>
          <p:cNvSpPr txBox="1"/>
          <p:nvPr/>
        </p:nvSpPr>
        <p:spPr>
          <a:xfrm>
            <a:off x="3378200" y="1028827"/>
            <a:ext cx="11049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/>
              <a:t>FSP1.TG</a:t>
            </a:r>
          </a:p>
          <a:p>
            <a:r>
              <a:rPr kumimoji="1" lang="en-US" altLang="ja-JP" sz="1600" b="1" i="1" dirty="0"/>
              <a:t>Ager</a:t>
            </a:r>
            <a:r>
              <a:rPr lang="en-US" altLang="ja-JP" sz="1600" b="1" dirty="0"/>
              <a:t>+/+</a:t>
            </a:r>
            <a:endParaRPr kumimoji="1" lang="ja-JP" altLang="en-US" sz="1600" dirty="0"/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A919EFAD-9207-449B-B0A1-467A29A5437D}"/>
              </a:ext>
            </a:extLst>
          </p:cNvPr>
          <p:cNvSpPr/>
          <p:nvPr/>
        </p:nvSpPr>
        <p:spPr>
          <a:xfrm>
            <a:off x="276064" y="3625334"/>
            <a:ext cx="75741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i="1" dirty="0"/>
              <a:t>Ager-/-</a:t>
            </a:r>
            <a:endParaRPr lang="ja-JP" altLang="en-US" dirty="0"/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479DAB58-1A04-4B42-969C-E6DE1C3C60E2}"/>
              </a:ext>
            </a:extLst>
          </p:cNvPr>
          <p:cNvSpPr/>
          <p:nvPr/>
        </p:nvSpPr>
        <p:spPr>
          <a:xfrm>
            <a:off x="288763" y="1034534"/>
            <a:ext cx="74471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dirty="0"/>
              <a:t>Wild</a:t>
            </a:r>
            <a:endParaRPr lang="ja-JP" altLang="en-US" b="1" dirty="0"/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15E9482D-9991-432C-AC5E-5C96C3224A9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65500" y="3349959"/>
            <a:ext cx="3046525" cy="2301541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308136B-D432-485D-A66A-6533255C8193}"/>
              </a:ext>
            </a:extLst>
          </p:cNvPr>
          <p:cNvSpPr txBox="1"/>
          <p:nvPr/>
        </p:nvSpPr>
        <p:spPr>
          <a:xfrm>
            <a:off x="3378200" y="3378327"/>
            <a:ext cx="13589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/>
              <a:t>FSP1.TG</a:t>
            </a:r>
          </a:p>
          <a:p>
            <a:r>
              <a:rPr kumimoji="1" lang="en-US" altLang="ja-JP" sz="1600" b="1" i="1" dirty="0"/>
              <a:t>Ager-/-</a:t>
            </a:r>
            <a:endParaRPr kumimoji="1" lang="ja-JP" altLang="en-US" sz="1600" dirty="0"/>
          </a:p>
        </p:txBody>
      </p:sp>
      <p:pic>
        <p:nvPicPr>
          <p:cNvPr id="13" name="図 12">
            <a:extLst>
              <a:ext uri="{FF2B5EF4-FFF2-40B4-BE49-F238E27FC236}">
                <a16:creationId xmlns:a16="http://schemas.microsoft.com/office/drawing/2014/main" id="{97FBC77A-3C2F-4068-B19C-1825DA8E583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8764" y="3360950"/>
            <a:ext cx="3038200" cy="2301541"/>
          </a:xfrm>
          <a:prstGeom prst="rect">
            <a:avLst/>
          </a:prstGeom>
        </p:spPr>
      </p:pic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31A93B84-42FC-43B5-91A8-2B809376A955}"/>
              </a:ext>
            </a:extLst>
          </p:cNvPr>
          <p:cNvSpPr/>
          <p:nvPr/>
        </p:nvSpPr>
        <p:spPr>
          <a:xfrm>
            <a:off x="314164" y="3371334"/>
            <a:ext cx="103203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i="1" dirty="0"/>
              <a:t>Ager</a:t>
            </a:r>
            <a:r>
              <a:rPr lang="en-US" altLang="ja-JP" b="1" dirty="0"/>
              <a:t>-/-</a:t>
            </a:r>
            <a:endParaRPr lang="ja-JP" altLang="en-US" b="1" dirty="0"/>
          </a:p>
        </p:txBody>
      </p:sp>
      <p:pic>
        <p:nvPicPr>
          <p:cNvPr id="15" name="図 14">
            <a:extLst>
              <a:ext uri="{FF2B5EF4-FFF2-40B4-BE49-F238E27FC236}">
                <a16:creationId xmlns:a16="http://schemas.microsoft.com/office/drawing/2014/main" id="{CE28D55F-A5AF-42CE-BB74-44012B39DF0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669008" y="1663700"/>
            <a:ext cx="5236026" cy="3759199"/>
          </a:xfrm>
          <a:prstGeom prst="rect">
            <a:avLst/>
          </a:prstGeom>
        </p:spPr>
      </p:pic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7ED54AAC-58E6-46A7-91A3-EB47E1460BDA}"/>
              </a:ext>
            </a:extLst>
          </p:cNvPr>
          <p:cNvSpPr/>
          <p:nvPr/>
        </p:nvSpPr>
        <p:spPr>
          <a:xfrm>
            <a:off x="25400" y="6471789"/>
            <a:ext cx="234711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latin typeface="+mj-lt"/>
              </a:rPr>
              <a:t>Supplementary Fig. 7. </a:t>
            </a:r>
            <a:endParaRPr lang="ja-JP" altLang="en-US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6907139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図 28">
            <a:extLst>
              <a:ext uri="{FF2B5EF4-FFF2-40B4-BE49-F238E27FC236}">
                <a16:creationId xmlns:a16="http://schemas.microsoft.com/office/drawing/2014/main" id="{04B65D1C-E8DE-4DD4-8BD5-6A86D4B46F1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1802" y="135470"/>
            <a:ext cx="1971384" cy="5867400"/>
          </a:xfrm>
          <a:prstGeom prst="rect">
            <a:avLst/>
          </a:prstGeom>
        </p:spPr>
      </p:pic>
      <p:pic>
        <p:nvPicPr>
          <p:cNvPr id="30" name="図 29">
            <a:extLst>
              <a:ext uri="{FF2B5EF4-FFF2-40B4-BE49-F238E27FC236}">
                <a16:creationId xmlns:a16="http://schemas.microsoft.com/office/drawing/2014/main" id="{00894966-BFAB-4B62-8C8E-09960535FBC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24595" y="135470"/>
            <a:ext cx="1971384" cy="5867400"/>
          </a:xfrm>
          <a:prstGeom prst="rect">
            <a:avLst/>
          </a:prstGeom>
        </p:spPr>
      </p:pic>
      <p:pic>
        <p:nvPicPr>
          <p:cNvPr id="31" name="図 30">
            <a:extLst>
              <a:ext uri="{FF2B5EF4-FFF2-40B4-BE49-F238E27FC236}">
                <a16:creationId xmlns:a16="http://schemas.microsoft.com/office/drawing/2014/main" id="{61614390-E904-451E-8EBF-E9D07014516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07390" y="135470"/>
            <a:ext cx="1971384" cy="5867400"/>
          </a:xfrm>
          <a:prstGeom prst="rect">
            <a:avLst/>
          </a:prstGeom>
        </p:spPr>
      </p:pic>
      <p:pic>
        <p:nvPicPr>
          <p:cNvPr id="32" name="図 31">
            <a:extLst>
              <a:ext uri="{FF2B5EF4-FFF2-40B4-BE49-F238E27FC236}">
                <a16:creationId xmlns:a16="http://schemas.microsoft.com/office/drawing/2014/main" id="{D86DABF5-4D72-4FDF-9095-DE707B8E2FB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198651" y="135470"/>
            <a:ext cx="1971384" cy="5867400"/>
          </a:xfrm>
          <a:prstGeom prst="rect">
            <a:avLst/>
          </a:prstGeom>
        </p:spPr>
      </p:pic>
      <p:pic>
        <p:nvPicPr>
          <p:cNvPr id="33" name="図 32">
            <a:extLst>
              <a:ext uri="{FF2B5EF4-FFF2-40B4-BE49-F238E27FC236}">
                <a16:creationId xmlns:a16="http://schemas.microsoft.com/office/drawing/2014/main" id="{2D2A3111-7888-483D-931F-5ACCBB9085D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289913" y="135470"/>
            <a:ext cx="1971384" cy="5867400"/>
          </a:xfrm>
          <a:prstGeom prst="rect">
            <a:avLst/>
          </a:prstGeom>
        </p:spPr>
      </p:pic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617F2A1D-0E65-4BE3-8BB9-CB046F537D79}"/>
              </a:ext>
            </a:extLst>
          </p:cNvPr>
          <p:cNvSpPr txBox="1"/>
          <p:nvPr/>
        </p:nvSpPr>
        <p:spPr>
          <a:xfrm>
            <a:off x="50799" y="6146797"/>
            <a:ext cx="8190063" cy="8002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+mj-lt"/>
              </a:rPr>
              <a:t>Supplementary Table. The 142 genes upregulated more than 5-fold by microarray. </a:t>
            </a:r>
          </a:p>
          <a:p>
            <a:r>
              <a:rPr lang="en-US" altLang="ja-JP" sz="1600" b="1" dirty="0">
                <a:latin typeface="+mj-lt"/>
              </a:rPr>
              <a:t>Four genes (yellow boxes) are associated with </a:t>
            </a:r>
            <a:r>
              <a:rPr kumimoji="1" lang="en-US" altLang="ja-JP" sz="1600" b="1" dirty="0">
                <a:latin typeface="+mj-lt"/>
              </a:rPr>
              <a:t> Nrf2 activation.</a:t>
            </a:r>
          </a:p>
          <a:p>
            <a:endParaRPr kumimoji="1" lang="ja-JP" altLang="en-US" sz="1200" b="1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3666225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973D52D6-E027-40CB-B264-F37AD8BEA6C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42501" y="1172009"/>
            <a:ext cx="6107683" cy="3687858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68DA4F63-B251-4B92-9DE1-4BD2793BFD4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1816" y="1340379"/>
            <a:ext cx="5676900" cy="3533775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2681B98-982B-46B3-AF0A-02B4CD8823E4}"/>
              </a:ext>
            </a:extLst>
          </p:cNvPr>
          <p:cNvSpPr txBox="1"/>
          <p:nvPr/>
        </p:nvSpPr>
        <p:spPr>
          <a:xfrm>
            <a:off x="0" y="6488668"/>
            <a:ext cx="50257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+mj-lt"/>
              </a:rPr>
              <a:t>Supplementary Fig. 1a. Full length blots of Fig. 1c </a:t>
            </a:r>
            <a:endParaRPr kumimoji="1" lang="ja-JP" altLang="en-US" b="1" dirty="0">
              <a:latin typeface="+mj-lt"/>
            </a:endParaRPr>
          </a:p>
        </p:txBody>
      </p: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0A9C0ABD-A680-4CF6-924B-938484028435}"/>
              </a:ext>
            </a:extLst>
          </p:cNvPr>
          <p:cNvGrpSpPr/>
          <p:nvPr/>
        </p:nvGrpSpPr>
        <p:grpSpPr>
          <a:xfrm>
            <a:off x="248582" y="1563487"/>
            <a:ext cx="444352" cy="261610"/>
            <a:chOff x="3436624" y="5558844"/>
            <a:chExt cx="444352" cy="261610"/>
          </a:xfrm>
        </p:grpSpPr>
        <p:sp>
          <p:nvSpPr>
            <p:cNvPr id="6" name="正方形/長方形 5">
              <a:extLst>
                <a:ext uri="{FF2B5EF4-FFF2-40B4-BE49-F238E27FC236}">
                  <a16:creationId xmlns:a16="http://schemas.microsoft.com/office/drawing/2014/main" id="{EBCDC79E-1394-47F6-991A-BA4CBFB36829}"/>
                </a:ext>
              </a:extLst>
            </p:cNvPr>
            <p:cNvSpPr/>
            <p:nvPr/>
          </p:nvSpPr>
          <p:spPr>
            <a:xfrm>
              <a:off x="3478759" y="5601729"/>
              <a:ext cx="343600" cy="16929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FC34E322-18BD-4F43-92B3-7A30AE0A6573}"/>
                </a:ext>
              </a:extLst>
            </p:cNvPr>
            <p:cNvSpPr txBox="1"/>
            <p:nvPr/>
          </p:nvSpPr>
          <p:spPr>
            <a:xfrm>
              <a:off x="3436624" y="5558844"/>
              <a:ext cx="44435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/>
                <a:t>kDa</a:t>
              </a:r>
              <a:endParaRPr kumimoji="1" lang="ja-JP" altLang="en-US" sz="1100" dirty="0"/>
            </a:p>
          </p:txBody>
        </p:sp>
      </p:grp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F9B1D557-25BF-4259-8D38-4A1D6DB2A1CA}"/>
              </a:ext>
            </a:extLst>
          </p:cNvPr>
          <p:cNvGrpSpPr/>
          <p:nvPr/>
        </p:nvGrpSpPr>
        <p:grpSpPr>
          <a:xfrm>
            <a:off x="6192171" y="1691173"/>
            <a:ext cx="444352" cy="261610"/>
            <a:chOff x="3436624" y="5558844"/>
            <a:chExt cx="444352" cy="261610"/>
          </a:xfrm>
        </p:grpSpPr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258BC892-7FDB-495F-A14D-60DA513E7865}"/>
                </a:ext>
              </a:extLst>
            </p:cNvPr>
            <p:cNvSpPr/>
            <p:nvPr/>
          </p:nvSpPr>
          <p:spPr>
            <a:xfrm>
              <a:off x="3478759" y="5601729"/>
              <a:ext cx="343600" cy="16929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A7321D6F-D46C-41CE-89B6-0BCA0E6AAB9F}"/>
                </a:ext>
              </a:extLst>
            </p:cNvPr>
            <p:cNvSpPr txBox="1"/>
            <p:nvPr/>
          </p:nvSpPr>
          <p:spPr>
            <a:xfrm>
              <a:off x="3436624" y="5558844"/>
              <a:ext cx="44435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/>
                <a:t>kDa</a:t>
              </a:r>
              <a:endParaRPr kumimoji="1" lang="ja-JP" altLang="en-US" sz="1100" dirty="0"/>
            </a:p>
          </p:txBody>
        </p:sp>
      </p:grpSp>
    </p:spTree>
    <p:extLst>
      <p:ext uri="{BB962C8B-B14F-4D97-AF65-F5344CB8AC3E}">
        <p14:creationId xmlns:p14="http://schemas.microsoft.com/office/powerpoint/2010/main" val="16691599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B3879A71-A8DE-4807-809E-F99D12F751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56790" y="3429000"/>
            <a:ext cx="5386863" cy="2749378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6D20532E-B1CA-446B-893D-9A81B26F555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80848" y="3429000"/>
            <a:ext cx="5162357" cy="2808816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B158623C-8F9F-4C23-BA75-5FAB8045277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56791" y="241804"/>
            <a:ext cx="4902109" cy="3070008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0BA2CED3-75B9-4F03-8CFF-EB0AFEC3A33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35307" y="241804"/>
            <a:ext cx="5053440" cy="3070008"/>
          </a:xfrm>
          <a:prstGeom prst="rect">
            <a:avLst/>
          </a:prstGeom>
        </p:spPr>
      </p:pic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EA78D73A-B43E-4EEB-8F87-F7B07C11C7D6}"/>
              </a:ext>
            </a:extLst>
          </p:cNvPr>
          <p:cNvGrpSpPr/>
          <p:nvPr/>
        </p:nvGrpSpPr>
        <p:grpSpPr>
          <a:xfrm>
            <a:off x="1335981" y="591419"/>
            <a:ext cx="444352" cy="261610"/>
            <a:chOff x="3436624" y="5558844"/>
            <a:chExt cx="444352" cy="261610"/>
          </a:xfrm>
        </p:grpSpPr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B8B80144-D533-462C-80E3-D5C8D13F5ED5}"/>
                </a:ext>
              </a:extLst>
            </p:cNvPr>
            <p:cNvSpPr/>
            <p:nvPr/>
          </p:nvSpPr>
          <p:spPr>
            <a:xfrm>
              <a:off x="3478759" y="5601729"/>
              <a:ext cx="343600" cy="16929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E700BC06-7C9D-45FD-81CC-B8E7CD1ED441}"/>
                </a:ext>
              </a:extLst>
            </p:cNvPr>
            <p:cNvSpPr txBox="1"/>
            <p:nvPr/>
          </p:nvSpPr>
          <p:spPr>
            <a:xfrm>
              <a:off x="3436624" y="5558844"/>
              <a:ext cx="44435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/>
                <a:t>kDa</a:t>
              </a:r>
              <a:endParaRPr kumimoji="1" lang="ja-JP" altLang="en-US" sz="1100" dirty="0"/>
            </a:p>
          </p:txBody>
        </p:sp>
      </p:grp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C7C05034-4415-41D8-8591-1E6859BEA30B}"/>
              </a:ext>
            </a:extLst>
          </p:cNvPr>
          <p:cNvGrpSpPr/>
          <p:nvPr/>
        </p:nvGrpSpPr>
        <p:grpSpPr>
          <a:xfrm>
            <a:off x="6674083" y="673793"/>
            <a:ext cx="444352" cy="261610"/>
            <a:chOff x="3436624" y="5558844"/>
            <a:chExt cx="444352" cy="261610"/>
          </a:xfrm>
        </p:grpSpPr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3CF6BD87-D511-4292-915D-32BFBEB13FF1}"/>
                </a:ext>
              </a:extLst>
            </p:cNvPr>
            <p:cNvSpPr/>
            <p:nvPr/>
          </p:nvSpPr>
          <p:spPr>
            <a:xfrm>
              <a:off x="3478759" y="5601729"/>
              <a:ext cx="343600" cy="16929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504DCBA1-B6DD-4EC8-8434-46B11632F7BE}"/>
                </a:ext>
              </a:extLst>
            </p:cNvPr>
            <p:cNvSpPr txBox="1"/>
            <p:nvPr/>
          </p:nvSpPr>
          <p:spPr>
            <a:xfrm>
              <a:off x="3436624" y="5558844"/>
              <a:ext cx="44435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/>
                <a:t>kDa</a:t>
              </a:r>
              <a:endParaRPr kumimoji="1" lang="ja-JP" altLang="en-US" sz="1100" dirty="0"/>
            </a:p>
          </p:txBody>
        </p:sp>
      </p:grp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ADFCC4F1-EF58-4BCD-8F98-3744378376B5}"/>
              </a:ext>
            </a:extLst>
          </p:cNvPr>
          <p:cNvGrpSpPr/>
          <p:nvPr/>
        </p:nvGrpSpPr>
        <p:grpSpPr>
          <a:xfrm>
            <a:off x="1228891" y="3400523"/>
            <a:ext cx="444352" cy="261610"/>
            <a:chOff x="3436624" y="5558844"/>
            <a:chExt cx="444352" cy="261610"/>
          </a:xfrm>
        </p:grpSpPr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FE92ACDD-E192-44ED-9A79-603994144ADD}"/>
                </a:ext>
              </a:extLst>
            </p:cNvPr>
            <p:cNvSpPr/>
            <p:nvPr/>
          </p:nvSpPr>
          <p:spPr>
            <a:xfrm>
              <a:off x="3478759" y="5601729"/>
              <a:ext cx="343600" cy="16929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2A74387E-578E-4F11-8DCA-909B90F566C3}"/>
                </a:ext>
              </a:extLst>
            </p:cNvPr>
            <p:cNvSpPr txBox="1"/>
            <p:nvPr/>
          </p:nvSpPr>
          <p:spPr>
            <a:xfrm>
              <a:off x="3436624" y="5558844"/>
              <a:ext cx="44435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/>
                <a:t>kDa</a:t>
              </a:r>
              <a:endParaRPr kumimoji="1" lang="ja-JP" altLang="en-US" sz="1100" dirty="0"/>
            </a:p>
          </p:txBody>
        </p:sp>
      </p:grp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6E35BE59-E3E3-457F-8549-B3509C1A9C8F}"/>
              </a:ext>
            </a:extLst>
          </p:cNvPr>
          <p:cNvGrpSpPr/>
          <p:nvPr/>
        </p:nvGrpSpPr>
        <p:grpSpPr>
          <a:xfrm>
            <a:off x="6731759" y="3392296"/>
            <a:ext cx="444352" cy="261610"/>
            <a:chOff x="3436624" y="5558844"/>
            <a:chExt cx="444352" cy="261610"/>
          </a:xfrm>
        </p:grpSpPr>
        <p:sp>
          <p:nvSpPr>
            <p:cNvPr id="17" name="正方形/長方形 16">
              <a:extLst>
                <a:ext uri="{FF2B5EF4-FFF2-40B4-BE49-F238E27FC236}">
                  <a16:creationId xmlns:a16="http://schemas.microsoft.com/office/drawing/2014/main" id="{82F291C6-756F-4176-9DDF-0E0A7683B618}"/>
                </a:ext>
              </a:extLst>
            </p:cNvPr>
            <p:cNvSpPr/>
            <p:nvPr/>
          </p:nvSpPr>
          <p:spPr>
            <a:xfrm>
              <a:off x="3478759" y="5601729"/>
              <a:ext cx="343600" cy="16929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47272D68-DC13-48F1-83A6-65BB1545958D}"/>
                </a:ext>
              </a:extLst>
            </p:cNvPr>
            <p:cNvSpPr txBox="1"/>
            <p:nvPr/>
          </p:nvSpPr>
          <p:spPr>
            <a:xfrm>
              <a:off x="3436624" y="5558844"/>
              <a:ext cx="44435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/>
                <a:t>kDa</a:t>
              </a:r>
              <a:endParaRPr kumimoji="1" lang="ja-JP" altLang="en-US" sz="1100" dirty="0"/>
            </a:p>
          </p:txBody>
        </p:sp>
      </p:grp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1D35D3C7-5153-4C2B-B4A3-691A355FCCB3}"/>
              </a:ext>
            </a:extLst>
          </p:cNvPr>
          <p:cNvSpPr/>
          <p:nvPr/>
        </p:nvSpPr>
        <p:spPr>
          <a:xfrm>
            <a:off x="12699" y="6458635"/>
            <a:ext cx="694751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+mj-lt"/>
              </a:rPr>
              <a:t>Supplementary Fig. 1b. Full length blots of Fig. 1c </a:t>
            </a:r>
            <a:endParaRPr lang="ja-JP" altLang="en-US" b="1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37845052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>
            <a:extLst>
              <a:ext uri="{FF2B5EF4-FFF2-40B4-BE49-F238E27FC236}">
                <a16:creationId xmlns:a16="http://schemas.microsoft.com/office/drawing/2014/main" id="{2EEC5F11-1480-4EAB-82E3-1318DE49D6D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18200" y="1187971"/>
            <a:ext cx="5622774" cy="3935942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98AA208E-FA26-4C76-BA91-AAA5063D004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3933" y="1053563"/>
            <a:ext cx="5162550" cy="413385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CBC16BF-70DC-42C3-BA61-B0F68A2D947D}"/>
              </a:ext>
            </a:extLst>
          </p:cNvPr>
          <p:cNvSpPr txBox="1"/>
          <p:nvPr/>
        </p:nvSpPr>
        <p:spPr>
          <a:xfrm>
            <a:off x="0" y="6472192"/>
            <a:ext cx="4916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+mj-lt"/>
              </a:rPr>
              <a:t>Supplementary Fig. 2. </a:t>
            </a:r>
            <a:r>
              <a:rPr kumimoji="1" lang="en-US" altLang="ja-JP" b="1" dirty="0">
                <a:latin typeface="+mj-lt"/>
              </a:rPr>
              <a:t>Full length blots of Fig. 2a </a:t>
            </a:r>
            <a:endParaRPr kumimoji="1" lang="ja-JP" altLang="en-US" b="1" dirty="0">
              <a:latin typeface="+mj-lt"/>
            </a:endParaRP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9E9BA7F9-3207-4716-937C-7BEAB578E06A}"/>
              </a:ext>
            </a:extLst>
          </p:cNvPr>
          <p:cNvGrpSpPr/>
          <p:nvPr/>
        </p:nvGrpSpPr>
        <p:grpSpPr>
          <a:xfrm>
            <a:off x="312430" y="1794151"/>
            <a:ext cx="444352" cy="261610"/>
            <a:chOff x="3436624" y="5558844"/>
            <a:chExt cx="444352" cy="261610"/>
          </a:xfrm>
        </p:grpSpPr>
        <p:sp>
          <p:nvSpPr>
            <p:cNvPr id="6" name="正方形/長方形 5">
              <a:extLst>
                <a:ext uri="{FF2B5EF4-FFF2-40B4-BE49-F238E27FC236}">
                  <a16:creationId xmlns:a16="http://schemas.microsoft.com/office/drawing/2014/main" id="{2E119A8A-FFBD-4481-A5B5-59B558C39FF2}"/>
                </a:ext>
              </a:extLst>
            </p:cNvPr>
            <p:cNvSpPr/>
            <p:nvPr/>
          </p:nvSpPr>
          <p:spPr>
            <a:xfrm>
              <a:off x="3478759" y="5601729"/>
              <a:ext cx="343600" cy="16929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ED83C841-C4B5-4757-B2F2-3A1E6ECFAAF1}"/>
                </a:ext>
              </a:extLst>
            </p:cNvPr>
            <p:cNvSpPr txBox="1"/>
            <p:nvPr/>
          </p:nvSpPr>
          <p:spPr>
            <a:xfrm>
              <a:off x="3436624" y="5558844"/>
              <a:ext cx="44435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/>
                <a:t>kDa</a:t>
              </a:r>
              <a:endParaRPr kumimoji="1" lang="ja-JP" altLang="en-US" sz="1100" dirty="0"/>
            </a:p>
          </p:txBody>
        </p:sp>
      </p:grp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34030779-BB76-4939-9E50-13920D6217F8}"/>
              </a:ext>
            </a:extLst>
          </p:cNvPr>
          <p:cNvGrpSpPr/>
          <p:nvPr/>
        </p:nvGrpSpPr>
        <p:grpSpPr>
          <a:xfrm>
            <a:off x="6343889" y="1734767"/>
            <a:ext cx="444352" cy="261610"/>
            <a:chOff x="3436624" y="5558844"/>
            <a:chExt cx="444352" cy="261610"/>
          </a:xfrm>
        </p:grpSpPr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37F648B0-1129-40AC-8F33-23F7F73F92E4}"/>
                </a:ext>
              </a:extLst>
            </p:cNvPr>
            <p:cNvSpPr/>
            <p:nvPr/>
          </p:nvSpPr>
          <p:spPr>
            <a:xfrm>
              <a:off x="3478759" y="5601729"/>
              <a:ext cx="343600" cy="16929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84C2E102-6A1D-4B00-B3EE-FFE084FCE740}"/>
                </a:ext>
              </a:extLst>
            </p:cNvPr>
            <p:cNvSpPr txBox="1"/>
            <p:nvPr/>
          </p:nvSpPr>
          <p:spPr>
            <a:xfrm>
              <a:off x="3436624" y="5558844"/>
              <a:ext cx="44435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/>
                <a:t>kDa</a:t>
              </a:r>
              <a:endParaRPr kumimoji="1" lang="ja-JP" altLang="en-US" sz="1100" dirty="0"/>
            </a:p>
          </p:txBody>
        </p:sp>
      </p:grpSp>
      <p:cxnSp>
        <p:nvCxnSpPr>
          <p:cNvPr id="3" name="直線矢印コネクタ 2">
            <a:extLst>
              <a:ext uri="{FF2B5EF4-FFF2-40B4-BE49-F238E27FC236}">
                <a16:creationId xmlns:a16="http://schemas.microsoft.com/office/drawing/2014/main" id="{34B1F053-EFDC-4291-8960-6AF5C176FC9A}"/>
              </a:ext>
            </a:extLst>
          </p:cNvPr>
          <p:cNvCxnSpPr/>
          <p:nvPr/>
        </p:nvCxnSpPr>
        <p:spPr>
          <a:xfrm flipH="1">
            <a:off x="5118100" y="2438400"/>
            <a:ext cx="2921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6EA0D61D-197B-4504-A543-FACE1ED32CAB}"/>
              </a:ext>
            </a:extLst>
          </p:cNvPr>
          <p:cNvSpPr txBox="1"/>
          <p:nvPr/>
        </p:nvSpPr>
        <p:spPr>
          <a:xfrm>
            <a:off x="5359400" y="2298700"/>
            <a:ext cx="5469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Nrf2</a:t>
            </a:r>
            <a:endParaRPr kumimoji="1" lang="ja-JP" altLang="en-US" sz="1400" dirty="0"/>
          </a:p>
        </p:txBody>
      </p:sp>
      <p:cxnSp>
        <p:nvCxnSpPr>
          <p:cNvPr id="14" name="直線矢印コネクタ 13">
            <a:extLst>
              <a:ext uri="{FF2B5EF4-FFF2-40B4-BE49-F238E27FC236}">
                <a16:creationId xmlns:a16="http://schemas.microsoft.com/office/drawing/2014/main" id="{822ED3D8-A87A-4F36-9538-99BE7FDCD734}"/>
              </a:ext>
            </a:extLst>
          </p:cNvPr>
          <p:cNvCxnSpPr/>
          <p:nvPr/>
        </p:nvCxnSpPr>
        <p:spPr>
          <a:xfrm flipH="1">
            <a:off x="11277600" y="2400300"/>
            <a:ext cx="2921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27E2937-66C7-4F1C-9003-E03BE3DFFE8D}"/>
              </a:ext>
            </a:extLst>
          </p:cNvPr>
          <p:cNvSpPr txBox="1"/>
          <p:nvPr/>
        </p:nvSpPr>
        <p:spPr>
          <a:xfrm>
            <a:off x="11518900" y="2260600"/>
            <a:ext cx="5469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Nrf2</a:t>
            </a:r>
            <a:endParaRPr kumimoji="1" lang="ja-JP" altLang="en-US" sz="1400" dirty="0"/>
          </a:p>
        </p:txBody>
      </p:sp>
      <p:cxnSp>
        <p:nvCxnSpPr>
          <p:cNvPr id="16" name="直線矢印コネクタ 15">
            <a:extLst>
              <a:ext uri="{FF2B5EF4-FFF2-40B4-BE49-F238E27FC236}">
                <a16:creationId xmlns:a16="http://schemas.microsoft.com/office/drawing/2014/main" id="{E56B8C7C-9B8D-49B5-8126-742D669DD6C9}"/>
              </a:ext>
            </a:extLst>
          </p:cNvPr>
          <p:cNvCxnSpPr/>
          <p:nvPr/>
        </p:nvCxnSpPr>
        <p:spPr>
          <a:xfrm flipH="1">
            <a:off x="11264900" y="2946400"/>
            <a:ext cx="2921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129E919F-CEB5-4C06-9C47-DAA68029CA0A}"/>
              </a:ext>
            </a:extLst>
          </p:cNvPr>
          <p:cNvSpPr txBox="1"/>
          <p:nvPr/>
        </p:nvSpPr>
        <p:spPr>
          <a:xfrm>
            <a:off x="11518900" y="2794000"/>
            <a:ext cx="6976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Lamin</a:t>
            </a: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37163514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D2633EEC-7A99-4690-B2B2-9C543A045C4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48400" y="568325"/>
            <a:ext cx="4972050" cy="2800350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E03FBECB-9730-4F72-90E7-692DA0B8F79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437" y="568325"/>
            <a:ext cx="4815753" cy="2800350"/>
          </a:xfrm>
          <a:prstGeom prst="rect">
            <a:avLst/>
          </a:prstGeom>
        </p:spPr>
      </p:pic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E6EB3459-93AB-41CE-958D-9EBC2DA3607D}"/>
              </a:ext>
            </a:extLst>
          </p:cNvPr>
          <p:cNvCxnSpPr/>
          <p:nvPr/>
        </p:nvCxnSpPr>
        <p:spPr>
          <a:xfrm>
            <a:off x="1257300" y="530225"/>
            <a:ext cx="15113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C00BA0FA-4CF6-44F6-96F4-C13C4B8ECE08}"/>
              </a:ext>
            </a:extLst>
          </p:cNvPr>
          <p:cNvCxnSpPr/>
          <p:nvPr/>
        </p:nvCxnSpPr>
        <p:spPr>
          <a:xfrm>
            <a:off x="2857500" y="530225"/>
            <a:ext cx="15113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A659F250-2F0E-43D8-8BEE-168861DEB139}"/>
              </a:ext>
            </a:extLst>
          </p:cNvPr>
          <p:cNvCxnSpPr/>
          <p:nvPr/>
        </p:nvCxnSpPr>
        <p:spPr>
          <a:xfrm>
            <a:off x="7607300" y="504825"/>
            <a:ext cx="15113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4330E1E2-E14F-4625-8545-16E0F788E110}"/>
              </a:ext>
            </a:extLst>
          </p:cNvPr>
          <p:cNvCxnSpPr/>
          <p:nvPr/>
        </p:nvCxnSpPr>
        <p:spPr>
          <a:xfrm>
            <a:off x="9220200" y="504825"/>
            <a:ext cx="15113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8CC39F6-D799-4CE9-A105-D03CAB0A7751}"/>
              </a:ext>
            </a:extLst>
          </p:cNvPr>
          <p:cNvSpPr txBox="1"/>
          <p:nvPr/>
        </p:nvSpPr>
        <p:spPr>
          <a:xfrm>
            <a:off x="1714500" y="160893"/>
            <a:ext cx="8755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FSP1-</a:t>
            </a:r>
            <a:endParaRPr kumimoji="1" lang="ja-JP" altLang="en-US" b="1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22AA4788-94D8-445F-80E8-A915F8FF9965}"/>
              </a:ext>
            </a:extLst>
          </p:cNvPr>
          <p:cNvSpPr txBox="1"/>
          <p:nvPr/>
        </p:nvSpPr>
        <p:spPr>
          <a:xfrm>
            <a:off x="3200400" y="173593"/>
            <a:ext cx="9476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FSP1+</a:t>
            </a:r>
            <a:endParaRPr kumimoji="1" lang="ja-JP" altLang="en-US" b="1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7BF1248-4194-4C2F-ADD1-0A1EE7B64CEC}"/>
              </a:ext>
            </a:extLst>
          </p:cNvPr>
          <p:cNvSpPr txBox="1"/>
          <p:nvPr/>
        </p:nvSpPr>
        <p:spPr>
          <a:xfrm>
            <a:off x="8013700" y="148193"/>
            <a:ext cx="8755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FSP1-</a:t>
            </a:r>
            <a:endParaRPr kumimoji="1" lang="ja-JP" altLang="en-US" b="1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D6ECC27E-12AD-459B-AA9C-326C3AFA8111}"/>
              </a:ext>
            </a:extLst>
          </p:cNvPr>
          <p:cNvSpPr txBox="1"/>
          <p:nvPr/>
        </p:nvSpPr>
        <p:spPr>
          <a:xfrm>
            <a:off x="9499600" y="160893"/>
            <a:ext cx="9476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FSP1+</a:t>
            </a:r>
            <a:endParaRPr kumimoji="1" lang="ja-JP" altLang="en-US" b="1" dirty="0"/>
          </a:p>
        </p:txBody>
      </p:sp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C2F72A76-49F3-4A39-BFA3-FAFF4F8128B0}"/>
              </a:ext>
            </a:extLst>
          </p:cNvPr>
          <p:cNvGrpSpPr/>
          <p:nvPr/>
        </p:nvGrpSpPr>
        <p:grpSpPr>
          <a:xfrm>
            <a:off x="6331189" y="553667"/>
            <a:ext cx="444352" cy="261610"/>
            <a:chOff x="3436624" y="5558844"/>
            <a:chExt cx="444352" cy="261610"/>
          </a:xfrm>
        </p:grpSpPr>
        <p:sp>
          <p:nvSpPr>
            <p:cNvPr id="19" name="正方形/長方形 18">
              <a:extLst>
                <a:ext uri="{FF2B5EF4-FFF2-40B4-BE49-F238E27FC236}">
                  <a16:creationId xmlns:a16="http://schemas.microsoft.com/office/drawing/2014/main" id="{CE3907FA-D14F-4346-97EF-05C8C7E63077}"/>
                </a:ext>
              </a:extLst>
            </p:cNvPr>
            <p:cNvSpPr/>
            <p:nvPr/>
          </p:nvSpPr>
          <p:spPr>
            <a:xfrm>
              <a:off x="3478759" y="5601729"/>
              <a:ext cx="343600" cy="16929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216C814A-71C4-4AF8-8F73-36AC5F426CA0}"/>
                </a:ext>
              </a:extLst>
            </p:cNvPr>
            <p:cNvSpPr txBox="1"/>
            <p:nvPr/>
          </p:nvSpPr>
          <p:spPr>
            <a:xfrm>
              <a:off x="3436624" y="5558844"/>
              <a:ext cx="44435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/>
                <a:t>kDa</a:t>
              </a:r>
              <a:endParaRPr kumimoji="1" lang="ja-JP" altLang="en-US" sz="1100" dirty="0"/>
            </a:p>
          </p:txBody>
        </p:sp>
      </p:grp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38BBE07D-0F1B-4A7D-8E65-7F317557EDA1}"/>
              </a:ext>
            </a:extLst>
          </p:cNvPr>
          <p:cNvGrpSpPr/>
          <p:nvPr/>
        </p:nvGrpSpPr>
        <p:grpSpPr>
          <a:xfrm>
            <a:off x="82789" y="566367"/>
            <a:ext cx="444352" cy="261610"/>
            <a:chOff x="3436624" y="5558844"/>
            <a:chExt cx="444352" cy="261610"/>
          </a:xfrm>
        </p:grpSpPr>
        <p:sp>
          <p:nvSpPr>
            <p:cNvPr id="22" name="正方形/長方形 21">
              <a:extLst>
                <a:ext uri="{FF2B5EF4-FFF2-40B4-BE49-F238E27FC236}">
                  <a16:creationId xmlns:a16="http://schemas.microsoft.com/office/drawing/2014/main" id="{5E739E35-2E8D-4CA2-978C-B14ECBE5E6E2}"/>
                </a:ext>
              </a:extLst>
            </p:cNvPr>
            <p:cNvSpPr/>
            <p:nvPr/>
          </p:nvSpPr>
          <p:spPr>
            <a:xfrm>
              <a:off x="3478759" y="5601729"/>
              <a:ext cx="343600" cy="16929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A5F255D1-E814-4946-A4E6-DDF009445067}"/>
                </a:ext>
              </a:extLst>
            </p:cNvPr>
            <p:cNvSpPr txBox="1"/>
            <p:nvPr/>
          </p:nvSpPr>
          <p:spPr>
            <a:xfrm>
              <a:off x="3436624" y="5558844"/>
              <a:ext cx="44435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/>
                <a:t>kDa</a:t>
              </a:r>
              <a:endParaRPr kumimoji="1" lang="ja-JP" altLang="en-US" sz="1100" dirty="0"/>
            </a:p>
          </p:txBody>
        </p:sp>
      </p:grp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9A62FF8A-393C-4F46-938F-F33BFB2308E5}"/>
              </a:ext>
            </a:extLst>
          </p:cNvPr>
          <p:cNvCxnSpPr/>
          <p:nvPr/>
        </p:nvCxnSpPr>
        <p:spPr>
          <a:xfrm flipH="1">
            <a:off x="10896600" y="1600200"/>
            <a:ext cx="4445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D4165507-2401-4A33-B580-C6EA4FABB1B7}"/>
              </a:ext>
            </a:extLst>
          </p:cNvPr>
          <p:cNvSpPr txBox="1"/>
          <p:nvPr/>
        </p:nvSpPr>
        <p:spPr>
          <a:xfrm>
            <a:off x="11341100" y="1446311"/>
            <a:ext cx="8499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β-actin</a:t>
            </a:r>
            <a:endParaRPr kumimoji="1" lang="ja-JP" altLang="en-US" sz="1400" dirty="0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DC80CDF7-C3B4-444B-90B2-A9504074E89A}"/>
              </a:ext>
            </a:extLst>
          </p:cNvPr>
          <p:cNvSpPr txBox="1"/>
          <p:nvPr/>
        </p:nvSpPr>
        <p:spPr>
          <a:xfrm>
            <a:off x="4595383" y="2603500"/>
            <a:ext cx="16530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c</a:t>
            </a:r>
            <a:r>
              <a:rPr kumimoji="1" lang="en-US" altLang="ja-JP" sz="1400" dirty="0"/>
              <a:t>leaved caspase3</a:t>
            </a:r>
            <a:endParaRPr kumimoji="1" lang="ja-JP" altLang="en-US" sz="1400" dirty="0"/>
          </a:p>
        </p:txBody>
      </p:sp>
      <p:cxnSp>
        <p:nvCxnSpPr>
          <p:cNvPr id="28" name="直線矢印コネクタ 27">
            <a:extLst>
              <a:ext uri="{FF2B5EF4-FFF2-40B4-BE49-F238E27FC236}">
                <a16:creationId xmlns:a16="http://schemas.microsoft.com/office/drawing/2014/main" id="{ECCA2703-6108-464E-82D1-20244F836F54}"/>
              </a:ext>
            </a:extLst>
          </p:cNvPr>
          <p:cNvCxnSpPr>
            <a:cxnSpLocks/>
          </p:cNvCxnSpPr>
          <p:nvPr/>
        </p:nvCxnSpPr>
        <p:spPr>
          <a:xfrm flipH="1">
            <a:off x="4483100" y="2794000"/>
            <a:ext cx="2032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0" name="図 29">
            <a:extLst>
              <a:ext uri="{FF2B5EF4-FFF2-40B4-BE49-F238E27FC236}">
                <a16:creationId xmlns:a16="http://schemas.microsoft.com/office/drawing/2014/main" id="{BFBDD06D-7247-425A-BDAB-0363E5C6BDD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74247" y="3657601"/>
            <a:ext cx="4076700" cy="2724150"/>
          </a:xfrm>
          <a:prstGeom prst="rect">
            <a:avLst/>
          </a:prstGeom>
        </p:spPr>
      </p:pic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354A85DE-78BB-41A7-960F-382EC9F35F94}"/>
              </a:ext>
            </a:extLst>
          </p:cNvPr>
          <p:cNvSpPr txBox="1"/>
          <p:nvPr/>
        </p:nvSpPr>
        <p:spPr>
          <a:xfrm rot="16200000">
            <a:off x="2201889" y="4758066"/>
            <a:ext cx="252024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b="1" dirty="0"/>
              <a:t>Cleaved caspase 3/b-actin</a:t>
            </a:r>
          </a:p>
          <a:p>
            <a:pPr algn="ctr"/>
            <a:r>
              <a:rPr lang="en-US" altLang="ja-JP" sz="1400" b="1" dirty="0"/>
              <a:t>Fold change</a:t>
            </a:r>
            <a:endParaRPr kumimoji="1" lang="ja-JP" altLang="en-US" sz="1400" b="1" dirty="0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679D9658-3E3B-45D5-8111-2DC4B5201990}"/>
              </a:ext>
            </a:extLst>
          </p:cNvPr>
          <p:cNvSpPr txBox="1"/>
          <p:nvPr/>
        </p:nvSpPr>
        <p:spPr>
          <a:xfrm>
            <a:off x="4775200" y="6269593"/>
            <a:ext cx="8755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FSP1-</a:t>
            </a:r>
            <a:endParaRPr kumimoji="1" lang="ja-JP" altLang="en-US" b="1" dirty="0"/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6E7F73AA-7AA5-455E-9A9A-F4F5D9B332A9}"/>
              </a:ext>
            </a:extLst>
          </p:cNvPr>
          <p:cNvSpPr txBox="1"/>
          <p:nvPr/>
        </p:nvSpPr>
        <p:spPr>
          <a:xfrm>
            <a:off x="6184900" y="6282293"/>
            <a:ext cx="9476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FSP1+</a:t>
            </a:r>
            <a:endParaRPr kumimoji="1" lang="ja-JP" altLang="en-US" b="1" dirty="0"/>
          </a:p>
        </p:txBody>
      </p:sp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8CCC582D-BCCC-4235-BD0E-23EE7C557F58}"/>
              </a:ext>
            </a:extLst>
          </p:cNvPr>
          <p:cNvSpPr/>
          <p:nvPr/>
        </p:nvSpPr>
        <p:spPr>
          <a:xfrm>
            <a:off x="0" y="6470652"/>
            <a:ext cx="234711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latin typeface="+mj-lt"/>
              </a:rPr>
              <a:t>Supplementary Fig. 3. </a:t>
            </a:r>
            <a:endParaRPr lang="ja-JP" altLang="en-US" dirty="0">
              <a:latin typeface="+mj-lt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1E1FC34A-821C-478B-BEC5-D859B8971193}"/>
              </a:ext>
            </a:extLst>
          </p:cNvPr>
          <p:cNvSpPr txBox="1"/>
          <p:nvPr/>
        </p:nvSpPr>
        <p:spPr>
          <a:xfrm>
            <a:off x="76200" y="47625"/>
            <a:ext cx="45076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a.</a:t>
            </a:r>
            <a:endParaRPr kumimoji="1" lang="ja-JP" altLang="en-US" sz="2400" b="1" dirty="0"/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3F0A273E-1B17-471E-B945-6113AB3B91D0}"/>
              </a:ext>
            </a:extLst>
          </p:cNvPr>
          <p:cNvSpPr txBox="1"/>
          <p:nvPr/>
        </p:nvSpPr>
        <p:spPr>
          <a:xfrm>
            <a:off x="6210300" y="47625"/>
            <a:ext cx="46038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b="1" dirty="0"/>
              <a:t>b</a:t>
            </a:r>
            <a:r>
              <a:rPr kumimoji="1" lang="en-US" altLang="ja-JP" sz="2400" b="1" dirty="0"/>
              <a:t>.</a:t>
            </a:r>
            <a:endParaRPr kumimoji="1" lang="ja-JP" altLang="en-US" sz="2400" b="1" dirty="0"/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E859E5AC-0842-4D95-96D5-5628D824D60E}"/>
              </a:ext>
            </a:extLst>
          </p:cNvPr>
          <p:cNvSpPr txBox="1"/>
          <p:nvPr/>
        </p:nvSpPr>
        <p:spPr>
          <a:xfrm>
            <a:off x="2730500" y="3476625"/>
            <a:ext cx="44114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c.</a:t>
            </a:r>
            <a:endParaRPr kumimoji="1" lang="ja-JP" alt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389031042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7D91BDAB-CEC1-4EFE-AC06-80AE1E621E7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31800"/>
            <a:ext cx="4257675" cy="302895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DDCE8326-336D-4840-B16A-51D61AC3F45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30638" y="403225"/>
            <a:ext cx="4505325" cy="3057525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6A182E74-4295-45F5-9E24-221588A7F30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72400" y="406400"/>
            <a:ext cx="4419600" cy="3105150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CAD7077D-3B7B-46A3-9127-179D4B15527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65975" y="4204698"/>
            <a:ext cx="2452022" cy="1839017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84411611-8A97-44C3-8881-E84516CC229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0346" y="4203700"/>
            <a:ext cx="2452021" cy="1828799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2844B6F-2E61-4236-9A9A-4CB417E6A611}"/>
              </a:ext>
            </a:extLst>
          </p:cNvPr>
          <p:cNvSpPr txBox="1"/>
          <p:nvPr/>
        </p:nvSpPr>
        <p:spPr>
          <a:xfrm>
            <a:off x="241300" y="4203700"/>
            <a:ext cx="6174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/>
              <a:t>Wild</a:t>
            </a:r>
            <a:endParaRPr kumimoji="1" lang="ja-JP" altLang="en-US" sz="1600" b="1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439198A-5DEE-446E-8B2B-10C91F8BBAF3}"/>
              </a:ext>
            </a:extLst>
          </p:cNvPr>
          <p:cNvSpPr txBox="1"/>
          <p:nvPr/>
        </p:nvSpPr>
        <p:spPr>
          <a:xfrm>
            <a:off x="5283200" y="4203700"/>
            <a:ext cx="10583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/>
              <a:t>FSP1.TG</a:t>
            </a:r>
            <a:endParaRPr kumimoji="1" lang="ja-JP" altLang="en-US" sz="1600" b="1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0A52CCE-D93E-4DA0-B327-CE2655850E25}"/>
              </a:ext>
            </a:extLst>
          </p:cNvPr>
          <p:cNvSpPr txBox="1"/>
          <p:nvPr/>
        </p:nvSpPr>
        <p:spPr>
          <a:xfrm>
            <a:off x="76200" y="47625"/>
            <a:ext cx="45076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a.</a:t>
            </a:r>
            <a:endParaRPr kumimoji="1" lang="ja-JP" altLang="en-US" sz="2400" b="1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EB308888-E16F-434F-A9F5-B5BAF35984B8}"/>
              </a:ext>
            </a:extLst>
          </p:cNvPr>
          <p:cNvSpPr txBox="1"/>
          <p:nvPr/>
        </p:nvSpPr>
        <p:spPr>
          <a:xfrm>
            <a:off x="50800" y="3641725"/>
            <a:ext cx="46038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b="1" dirty="0"/>
              <a:t>b</a:t>
            </a:r>
            <a:r>
              <a:rPr kumimoji="1" lang="en-US" altLang="ja-JP" sz="2400" b="1" dirty="0"/>
              <a:t>.</a:t>
            </a:r>
            <a:endParaRPr kumimoji="1" lang="ja-JP" altLang="en-US" sz="2400" b="1" dirty="0"/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0316EA8B-0EFF-406D-AA51-F0FC726CC50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742159" y="4203700"/>
            <a:ext cx="2435068" cy="1828799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A590F4EC-8792-4AEA-BF65-DABC33099790}"/>
              </a:ext>
            </a:extLst>
          </p:cNvPr>
          <p:cNvSpPr txBox="1"/>
          <p:nvPr/>
        </p:nvSpPr>
        <p:spPr>
          <a:xfrm>
            <a:off x="2768600" y="4229100"/>
            <a:ext cx="9236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i="1" dirty="0"/>
              <a:t>Ager</a:t>
            </a:r>
            <a:r>
              <a:rPr kumimoji="1" lang="en-US" altLang="ja-JP" sz="1600" b="1" dirty="0"/>
              <a:t>-/-</a:t>
            </a:r>
            <a:endParaRPr kumimoji="1" lang="ja-JP" altLang="en-US" sz="1600" b="1" dirty="0"/>
          </a:p>
        </p:txBody>
      </p:sp>
      <p:pic>
        <p:nvPicPr>
          <p:cNvPr id="14" name="図 13">
            <a:extLst>
              <a:ext uri="{FF2B5EF4-FFF2-40B4-BE49-F238E27FC236}">
                <a16:creationId xmlns:a16="http://schemas.microsoft.com/office/drawing/2014/main" id="{080E9745-6CB8-400B-8027-04979BE9AA5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861300" y="3870325"/>
            <a:ext cx="4276725" cy="2952750"/>
          </a:xfrm>
          <a:prstGeom prst="rect">
            <a:avLst/>
          </a:prstGeom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83CD2EB-4EAD-40A4-AF5D-FCF62E30AA84}"/>
              </a:ext>
            </a:extLst>
          </p:cNvPr>
          <p:cNvSpPr txBox="1"/>
          <p:nvPr/>
        </p:nvSpPr>
        <p:spPr>
          <a:xfrm>
            <a:off x="7785100" y="3654425"/>
            <a:ext cx="44114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c.</a:t>
            </a:r>
            <a:endParaRPr kumimoji="1" lang="ja-JP" altLang="en-US" sz="2400" b="1" dirty="0"/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359F5D03-A0EB-4EC9-BD73-3EF4773901F9}"/>
              </a:ext>
            </a:extLst>
          </p:cNvPr>
          <p:cNvSpPr/>
          <p:nvPr/>
        </p:nvSpPr>
        <p:spPr>
          <a:xfrm>
            <a:off x="76200" y="6471789"/>
            <a:ext cx="234711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latin typeface="+mj-lt"/>
              </a:rPr>
              <a:t>Supplementary Fig. 4. </a:t>
            </a:r>
            <a:endParaRPr lang="ja-JP" altLang="en-US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372583897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4CA3FE2F-3768-468A-A63C-02752F44BD9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62200" y="495300"/>
            <a:ext cx="3810000" cy="293370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0C5BB768-3AF8-428C-A164-2EA9896A3F0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72275" y="385762"/>
            <a:ext cx="3905250" cy="3152775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172C7828-3B7B-45BC-B94B-42564F5B648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80200" y="3640137"/>
            <a:ext cx="4038600" cy="3095625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46242043-C2FC-4730-ADAE-BF429E1516E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09800" y="3665536"/>
            <a:ext cx="4086225" cy="3095625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9F6C700-9622-46A3-A6FB-68AC7B892216}"/>
              </a:ext>
            </a:extLst>
          </p:cNvPr>
          <p:cNvSpPr txBox="1"/>
          <p:nvPr/>
        </p:nvSpPr>
        <p:spPr>
          <a:xfrm>
            <a:off x="4038600" y="157162"/>
            <a:ext cx="7729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HO-1</a:t>
            </a:r>
            <a:endParaRPr kumimoji="1" lang="ja-JP" altLang="en-US" b="1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1AFED17-1FA9-4309-A5FA-4E40E711464A}"/>
              </a:ext>
            </a:extLst>
          </p:cNvPr>
          <p:cNvSpPr txBox="1"/>
          <p:nvPr/>
        </p:nvSpPr>
        <p:spPr>
          <a:xfrm>
            <a:off x="8343900" y="157162"/>
            <a:ext cx="10631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Slc7a11</a:t>
            </a:r>
            <a:endParaRPr kumimoji="1" lang="ja-JP" altLang="en-US" b="1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DE7D291-4D92-4FEB-937F-B9375ACC25B1}"/>
              </a:ext>
            </a:extLst>
          </p:cNvPr>
          <p:cNvSpPr txBox="1"/>
          <p:nvPr/>
        </p:nvSpPr>
        <p:spPr>
          <a:xfrm>
            <a:off x="4038600" y="3471862"/>
            <a:ext cx="6511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CSE</a:t>
            </a:r>
            <a:endParaRPr kumimoji="1" lang="ja-JP" altLang="en-US" b="1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B4D05BE-BD4A-4870-BBFC-2D046C30E0CF}"/>
              </a:ext>
            </a:extLst>
          </p:cNvPr>
          <p:cNvSpPr txBox="1"/>
          <p:nvPr/>
        </p:nvSpPr>
        <p:spPr>
          <a:xfrm>
            <a:off x="8343900" y="3446462"/>
            <a:ext cx="10038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qstm1</a:t>
            </a:r>
            <a:endParaRPr kumimoji="1" lang="ja-JP" altLang="en-US" b="1" dirty="0"/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B6A7BC2A-4CB6-42A8-8E7C-843099FEE204}"/>
              </a:ext>
            </a:extLst>
          </p:cNvPr>
          <p:cNvSpPr/>
          <p:nvPr/>
        </p:nvSpPr>
        <p:spPr>
          <a:xfrm>
            <a:off x="3225800" y="3175000"/>
            <a:ext cx="6985000" cy="2968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3DF1594A-9B92-40F6-9630-967237DE3CEC}"/>
              </a:ext>
            </a:extLst>
          </p:cNvPr>
          <p:cNvSpPr/>
          <p:nvPr/>
        </p:nvSpPr>
        <p:spPr>
          <a:xfrm>
            <a:off x="3098800" y="6400800"/>
            <a:ext cx="6985000" cy="2968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6A6214C6-F931-4850-A67C-8AFA34E806CA}"/>
              </a:ext>
            </a:extLst>
          </p:cNvPr>
          <p:cNvSpPr txBox="1"/>
          <p:nvPr/>
        </p:nvSpPr>
        <p:spPr>
          <a:xfrm>
            <a:off x="3415280" y="3090942"/>
            <a:ext cx="668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Wild</a:t>
            </a:r>
            <a:endParaRPr kumimoji="1" lang="ja-JP" altLang="en-US" b="1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D04C9B6-6917-4A31-8D56-3DA853874FA3}"/>
              </a:ext>
            </a:extLst>
          </p:cNvPr>
          <p:cNvSpPr txBox="1"/>
          <p:nvPr/>
        </p:nvSpPr>
        <p:spPr>
          <a:xfrm>
            <a:off x="4554784" y="3095624"/>
            <a:ext cx="11689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FSP1.TG</a:t>
            </a:r>
            <a:endParaRPr kumimoji="1" lang="ja-JP" altLang="en-US" b="1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02531BD5-BEEC-4596-BB06-1E85EFC09EC1}"/>
              </a:ext>
            </a:extLst>
          </p:cNvPr>
          <p:cNvSpPr txBox="1"/>
          <p:nvPr/>
        </p:nvSpPr>
        <p:spPr>
          <a:xfrm>
            <a:off x="3427980" y="6304042"/>
            <a:ext cx="668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Wild</a:t>
            </a:r>
            <a:endParaRPr kumimoji="1" lang="ja-JP" altLang="en-US" b="1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64C9D51-2569-4F1F-B4C6-F2BFB49360C0}"/>
              </a:ext>
            </a:extLst>
          </p:cNvPr>
          <p:cNvSpPr txBox="1"/>
          <p:nvPr/>
        </p:nvSpPr>
        <p:spPr>
          <a:xfrm>
            <a:off x="4567484" y="6308724"/>
            <a:ext cx="11689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FSP1.TG</a:t>
            </a:r>
            <a:endParaRPr kumimoji="1" lang="ja-JP" altLang="en-US" b="1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317C83E4-580E-4779-AC63-D109733A6890}"/>
              </a:ext>
            </a:extLst>
          </p:cNvPr>
          <p:cNvSpPr txBox="1"/>
          <p:nvPr/>
        </p:nvSpPr>
        <p:spPr>
          <a:xfrm>
            <a:off x="7885680" y="6304042"/>
            <a:ext cx="668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Wild</a:t>
            </a:r>
            <a:endParaRPr kumimoji="1" lang="ja-JP" altLang="en-US" b="1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5517E7BD-0651-4D85-9012-F4D103D44D1B}"/>
              </a:ext>
            </a:extLst>
          </p:cNvPr>
          <p:cNvSpPr txBox="1"/>
          <p:nvPr/>
        </p:nvSpPr>
        <p:spPr>
          <a:xfrm>
            <a:off x="9025184" y="6308724"/>
            <a:ext cx="11689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FSP1.TG</a:t>
            </a:r>
            <a:endParaRPr kumimoji="1" lang="ja-JP" altLang="en-US" b="1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3B788B63-8109-48CA-9A1B-3CE0B57A05C0}"/>
              </a:ext>
            </a:extLst>
          </p:cNvPr>
          <p:cNvSpPr txBox="1"/>
          <p:nvPr/>
        </p:nvSpPr>
        <p:spPr>
          <a:xfrm>
            <a:off x="7911080" y="3103642"/>
            <a:ext cx="668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Wild</a:t>
            </a:r>
            <a:endParaRPr kumimoji="1" lang="ja-JP" altLang="en-US" b="1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4F8F792-4808-4A3D-BC1D-B1DCC66BE21C}"/>
              </a:ext>
            </a:extLst>
          </p:cNvPr>
          <p:cNvSpPr txBox="1"/>
          <p:nvPr/>
        </p:nvSpPr>
        <p:spPr>
          <a:xfrm>
            <a:off x="9050584" y="3108324"/>
            <a:ext cx="11689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FSP1.TG</a:t>
            </a:r>
            <a:endParaRPr kumimoji="1" lang="ja-JP" altLang="en-US" b="1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0C566F69-2BF3-4662-9798-11E66E35A926}"/>
              </a:ext>
            </a:extLst>
          </p:cNvPr>
          <p:cNvSpPr txBox="1"/>
          <p:nvPr/>
        </p:nvSpPr>
        <p:spPr>
          <a:xfrm rot="16200000">
            <a:off x="1397000" y="1662628"/>
            <a:ext cx="15568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Fold change</a:t>
            </a:r>
            <a:endParaRPr kumimoji="1" lang="ja-JP" altLang="en-US" b="1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0850936B-2B00-409C-AF3B-798C88C7C2C3}"/>
              </a:ext>
            </a:extLst>
          </p:cNvPr>
          <p:cNvSpPr txBox="1"/>
          <p:nvPr/>
        </p:nvSpPr>
        <p:spPr>
          <a:xfrm rot="16200000">
            <a:off x="1397000" y="4913828"/>
            <a:ext cx="15568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Fold change</a:t>
            </a:r>
            <a:endParaRPr kumimoji="1" lang="ja-JP" altLang="en-US" b="1" dirty="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38D84A43-04C7-437B-819C-BB319F8753F8}"/>
              </a:ext>
            </a:extLst>
          </p:cNvPr>
          <p:cNvSpPr txBox="1"/>
          <p:nvPr/>
        </p:nvSpPr>
        <p:spPr>
          <a:xfrm rot="16200000">
            <a:off x="5842000" y="1662628"/>
            <a:ext cx="15568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Fold change</a:t>
            </a:r>
            <a:endParaRPr kumimoji="1" lang="ja-JP" altLang="en-US" b="1" dirty="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F853ED1B-CDF5-4481-BF73-1CBE84D20690}"/>
              </a:ext>
            </a:extLst>
          </p:cNvPr>
          <p:cNvSpPr txBox="1"/>
          <p:nvPr/>
        </p:nvSpPr>
        <p:spPr>
          <a:xfrm rot="16200000">
            <a:off x="5842000" y="4913828"/>
            <a:ext cx="15568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Fold change</a:t>
            </a:r>
            <a:endParaRPr kumimoji="1" lang="ja-JP" altLang="en-US" b="1" dirty="0"/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4A82DDA1-83AE-4009-8395-E0C1FD1A3F3C}"/>
              </a:ext>
            </a:extLst>
          </p:cNvPr>
          <p:cNvSpPr/>
          <p:nvPr/>
        </p:nvSpPr>
        <p:spPr>
          <a:xfrm>
            <a:off x="25400" y="6471789"/>
            <a:ext cx="234711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latin typeface="+mj-lt"/>
              </a:rPr>
              <a:t>Supplementary Fig. 5. </a:t>
            </a:r>
            <a:endParaRPr lang="ja-JP" altLang="en-US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89840108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ABEB5771-8EFD-4C4B-950E-40D6F372A23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5137" y="1157859"/>
            <a:ext cx="3043761" cy="2296541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346FD840-1348-4B30-A667-C617361EBA4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5137" y="3507360"/>
            <a:ext cx="3052203" cy="2296540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F070BA0B-B11E-4E08-9F87-6F4343B5827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51237" y="1145159"/>
            <a:ext cx="3053595" cy="2296541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9C1E9EC4-C0A3-4F4F-9DFF-9B4DA8F6258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51237" y="3507360"/>
            <a:ext cx="3052203" cy="2298677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1BEB302-59F4-488C-8553-F76EBE5F7245}"/>
              </a:ext>
            </a:extLst>
          </p:cNvPr>
          <p:cNvSpPr txBox="1"/>
          <p:nvPr/>
        </p:nvSpPr>
        <p:spPr>
          <a:xfrm>
            <a:off x="3543300" y="1168527"/>
            <a:ext cx="11049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/>
              <a:t>FSP1.TG</a:t>
            </a:r>
          </a:p>
          <a:p>
            <a:r>
              <a:rPr kumimoji="1" lang="en-US" altLang="ja-JP" sz="1600" b="1" i="1" dirty="0"/>
              <a:t>Ager</a:t>
            </a:r>
            <a:r>
              <a:rPr lang="en-US" altLang="ja-JP" sz="1600" b="1" dirty="0"/>
              <a:t>+/+</a:t>
            </a:r>
            <a:endParaRPr kumimoji="1" lang="ja-JP" altLang="en-US" sz="1600" dirty="0"/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AF606F1B-AB4B-4CC8-8105-BE7C3204AA51}"/>
              </a:ext>
            </a:extLst>
          </p:cNvPr>
          <p:cNvSpPr/>
          <p:nvPr/>
        </p:nvSpPr>
        <p:spPr>
          <a:xfrm>
            <a:off x="453863" y="1174234"/>
            <a:ext cx="74471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dirty="0"/>
              <a:t>Wild</a:t>
            </a:r>
            <a:endParaRPr lang="ja-JP" altLang="en-US" b="1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62802DB-9940-4721-AED4-09280CD78CF2}"/>
              </a:ext>
            </a:extLst>
          </p:cNvPr>
          <p:cNvSpPr txBox="1"/>
          <p:nvPr/>
        </p:nvSpPr>
        <p:spPr>
          <a:xfrm>
            <a:off x="3543300" y="3518027"/>
            <a:ext cx="13589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/>
              <a:t>FSP1.TG</a:t>
            </a:r>
          </a:p>
          <a:p>
            <a:r>
              <a:rPr kumimoji="1" lang="en-US" altLang="ja-JP" sz="1600" b="1" i="1" dirty="0"/>
              <a:t>Ager-/-</a:t>
            </a:r>
            <a:endParaRPr kumimoji="1" lang="ja-JP" altLang="en-US" sz="1600" dirty="0"/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B1664036-C2CC-42BB-9679-0AEB3F0CE025}"/>
              </a:ext>
            </a:extLst>
          </p:cNvPr>
          <p:cNvSpPr/>
          <p:nvPr/>
        </p:nvSpPr>
        <p:spPr>
          <a:xfrm>
            <a:off x="479264" y="3511034"/>
            <a:ext cx="103203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i="1" dirty="0"/>
              <a:t>Ager</a:t>
            </a:r>
            <a:r>
              <a:rPr lang="en-US" altLang="ja-JP" b="1" dirty="0"/>
              <a:t>-/-</a:t>
            </a:r>
            <a:endParaRPr lang="ja-JP" altLang="en-US" b="1" dirty="0"/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0A4C8D97-6560-4ECD-A06A-64F8C94166E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801761" y="2105541"/>
            <a:ext cx="4152114" cy="3549650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AECDC9D5-D148-41F7-89A6-F71B9E8AA063}"/>
              </a:ext>
            </a:extLst>
          </p:cNvPr>
          <p:cNvSpPr txBox="1"/>
          <p:nvPr/>
        </p:nvSpPr>
        <p:spPr>
          <a:xfrm>
            <a:off x="7518400" y="4940300"/>
            <a:ext cx="3759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0</a:t>
            </a:r>
            <a:endParaRPr kumimoji="1" lang="ja-JP" altLang="en-US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D846861-93B8-4B94-9339-37DF2DBCE854}"/>
              </a:ext>
            </a:extLst>
          </p:cNvPr>
          <p:cNvSpPr txBox="1"/>
          <p:nvPr/>
        </p:nvSpPr>
        <p:spPr>
          <a:xfrm>
            <a:off x="7518400" y="4000500"/>
            <a:ext cx="3759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6</a:t>
            </a:r>
            <a:endParaRPr kumimoji="1" lang="ja-JP" altLang="en-US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5F8446E-0E0E-465A-8E57-D02BD9904780}"/>
              </a:ext>
            </a:extLst>
          </p:cNvPr>
          <p:cNvSpPr txBox="1"/>
          <p:nvPr/>
        </p:nvSpPr>
        <p:spPr>
          <a:xfrm>
            <a:off x="7391400" y="3073400"/>
            <a:ext cx="5156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12</a:t>
            </a:r>
            <a:endParaRPr kumimoji="1" lang="ja-JP" altLang="en-US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539AE1DB-2C6B-4374-9D62-0C07C8B4AD89}"/>
              </a:ext>
            </a:extLst>
          </p:cNvPr>
          <p:cNvSpPr txBox="1"/>
          <p:nvPr/>
        </p:nvSpPr>
        <p:spPr>
          <a:xfrm>
            <a:off x="7391400" y="2146300"/>
            <a:ext cx="5156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18</a:t>
            </a:r>
            <a:endParaRPr kumimoji="1" lang="ja-JP" altLang="en-US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A8797123-4367-48B9-B04C-17CF301B161A}"/>
              </a:ext>
            </a:extLst>
          </p:cNvPr>
          <p:cNvSpPr txBox="1"/>
          <p:nvPr/>
        </p:nvSpPr>
        <p:spPr>
          <a:xfrm rot="16200000">
            <a:off x="5339311" y="3624712"/>
            <a:ext cx="40505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+mj-lt"/>
                <a:cs typeface="Arial" panose="020B0604020202020204" pitchFamily="34" charset="0"/>
              </a:rPr>
              <a:t>Cleaved Caspase 3 positive area (x1000µ</a:t>
            </a:r>
            <a:r>
              <a:rPr lang="en-US" altLang="ja-JP" sz="1400" b="1" dirty="0">
                <a:latin typeface="+mj-lt"/>
                <a:cs typeface="Arial" panose="020B0604020202020204" pitchFamily="34" charset="0"/>
              </a:rPr>
              <a:t>mm</a:t>
            </a:r>
            <a:r>
              <a:rPr lang="en-US" altLang="ja-JP" sz="1400" b="1" baseline="30000" dirty="0">
                <a:latin typeface="+mj-lt"/>
                <a:cs typeface="Arial" panose="020B0604020202020204" pitchFamily="34" charset="0"/>
              </a:rPr>
              <a:t>2</a:t>
            </a:r>
            <a:r>
              <a:rPr lang="en-US" altLang="ja-JP" sz="1400" b="1" dirty="0">
                <a:latin typeface="+mj-lt"/>
                <a:cs typeface="Arial" panose="020B0604020202020204" pitchFamily="34" charset="0"/>
              </a:rPr>
              <a:t>)</a:t>
            </a:r>
            <a:endParaRPr kumimoji="1" lang="ja-JP" altLang="en-US" sz="1400" b="1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6FF53FCD-D55E-480B-A970-1F7D06CAD727}"/>
              </a:ext>
            </a:extLst>
          </p:cNvPr>
          <p:cNvSpPr/>
          <p:nvPr/>
        </p:nvSpPr>
        <p:spPr>
          <a:xfrm>
            <a:off x="25400" y="6471789"/>
            <a:ext cx="234711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latin typeface="+mj-lt"/>
              </a:rPr>
              <a:t>Supplementary Fig. 6. </a:t>
            </a:r>
            <a:endParaRPr lang="ja-JP" altLang="en-US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37360984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7</TotalTime>
  <Words>631</Words>
  <Application>Microsoft Office PowerPoint</Application>
  <PresentationFormat>ワイド画面</PresentationFormat>
  <Paragraphs>91</Paragraphs>
  <Slides>10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0</vt:i4>
      </vt:variant>
    </vt:vector>
  </HeadingPairs>
  <TitlesOfParts>
    <vt:vector size="17" baseType="lpstr">
      <vt:lpstr>游ゴシック</vt:lpstr>
      <vt:lpstr>游ゴシック Light</vt:lpstr>
      <vt:lpstr>游明朝</vt:lpstr>
      <vt:lpstr>Arial</vt:lpstr>
      <vt:lpstr>Symbo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User</dc:creator>
  <cp:lastModifiedBy>User</cp:lastModifiedBy>
  <cp:revision>47</cp:revision>
  <dcterms:created xsi:type="dcterms:W3CDTF">2023-08-14T08:43:44Z</dcterms:created>
  <dcterms:modified xsi:type="dcterms:W3CDTF">2023-12-04T08:25:11Z</dcterms:modified>
</cp:coreProperties>
</file>